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98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894F1C9-4637-AF98-51E8-D4EFEB0B6F4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2E9DCEB7-C2DB-6FA8-38A9-176854227A8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C323C09-9EDC-26DF-DECF-7B5D34B6DC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DF6FC-2809-C142-9C61-C15DD5480C82}" type="datetimeFigureOut">
              <a:rPr kumimoji="1" lang="ja-JP" altLang="en-US" smtClean="0"/>
              <a:t>2024/1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32C3F40-FC53-D4AF-A924-EE2040A44D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0BBEB72-5A07-4E0E-918C-630F27EAB7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6DC0F-3640-0248-8851-820917A4F8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30494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AA2153A-B9C2-57D4-DC26-B18909EC31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64C35F2-7FC2-3292-6AF4-B46971DBA1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1D5757D-4B99-802A-0C28-0E0D7819B5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DF6FC-2809-C142-9C61-C15DD5480C82}" type="datetimeFigureOut">
              <a:rPr kumimoji="1" lang="ja-JP" altLang="en-US" smtClean="0"/>
              <a:t>2024/1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AD8CC9E-4D4E-CF1F-A1E4-9CC8660933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8B21AD6-F9AA-F63E-B5C2-072EB6B867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6DC0F-3640-0248-8851-820917A4F8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84631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F6D48A7E-6BD2-B217-BA2D-58598CB594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CF590BC-3D44-FC87-69E4-012D26F4E9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EE31C49-5F1B-2938-EC8B-BF0D332156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DF6FC-2809-C142-9C61-C15DD5480C82}" type="datetimeFigureOut">
              <a:rPr kumimoji="1" lang="ja-JP" altLang="en-US" smtClean="0"/>
              <a:t>2024/1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041E0A4-FF82-C9FE-E659-56C85065C2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223748E-2B6C-1F46-D527-7FD09CD54B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6DC0F-3640-0248-8851-820917A4F8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95741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7D5F9DF-6ED0-26C4-385F-C283DFCC48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A15DD10-B54F-BBCA-CB02-A7DE0731E1B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F0AF030-F5F5-9AC2-BD2D-4D62F9486D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DF6FC-2809-C142-9C61-C15DD5480C82}" type="datetimeFigureOut">
              <a:rPr kumimoji="1" lang="ja-JP" altLang="en-US" smtClean="0"/>
              <a:t>2024/1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2C61000-EE4D-8C5B-0F3C-11059F3C6A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BC6D3F2-572F-D866-50EF-44EBF6D359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6DC0F-3640-0248-8851-820917A4F8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34075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D614E08-AE26-0C28-0FE0-6A6A35E358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79E34F3-5E0F-A2A2-07FE-E8D1207696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777F9A5-CB5B-02C0-488E-3B811ADBC5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DF6FC-2809-C142-9C61-C15DD5480C82}" type="datetimeFigureOut">
              <a:rPr kumimoji="1" lang="ja-JP" altLang="en-US" smtClean="0"/>
              <a:t>2024/1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1EEFBE6-6342-6233-A992-AC75AA91DE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F7FF5DF-CC2F-568E-33EB-301B9054DE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6DC0F-3640-0248-8851-820917A4F8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36722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0AE1F2C-0F87-B0DB-DB2B-66AB8E4006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4C4EA23-C52C-8C67-38E0-7E1C69DE64B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B7790B6-BD3B-0C32-FFD9-DD4EA279AE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9084EF8-99D7-027F-C7A4-A3667DCD4F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DF6FC-2809-C142-9C61-C15DD5480C82}" type="datetimeFigureOut">
              <a:rPr kumimoji="1" lang="ja-JP" altLang="en-US" smtClean="0"/>
              <a:t>2024/1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0A483DE-09C2-EEC2-467C-9CDC46A77E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98AD000-CD63-B6B9-8256-CCB8043FDE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6DC0F-3640-0248-8851-820917A4F8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04567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49E82B0-835F-99B2-CEF5-FDD01F0ED2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0761030-16E5-3201-4DF1-7FE1B97CF2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D8B14B8-E52F-D795-4299-AF6D26C648A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FA9881B-289C-9E0D-5471-85B436A6826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9CE666C-641C-F26F-86C2-EC30B485E93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849F7C1-D892-E6AC-5D45-B439044A1F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DF6FC-2809-C142-9C61-C15DD5480C82}" type="datetimeFigureOut">
              <a:rPr kumimoji="1" lang="ja-JP" altLang="en-US" smtClean="0"/>
              <a:t>2024/1/3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1BF3265-E480-01E8-40DD-687A992410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6A4E25E-31BD-CEA8-A4FC-0424D09F5D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6DC0F-3640-0248-8851-820917A4F8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06775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6B46E61-533D-BE5B-174C-94AC440603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C805E64-7749-D776-F2D3-02BF3B5274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DF6FC-2809-C142-9C61-C15DD5480C82}" type="datetimeFigureOut">
              <a:rPr kumimoji="1" lang="ja-JP" altLang="en-US" smtClean="0"/>
              <a:t>2024/1/3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D664A069-30F2-3D17-91FA-36849EFA59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06DF0EA-5022-9B41-CE06-012249445C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6DC0F-3640-0248-8851-820917A4F8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16165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C4CE19A-DF28-51A4-F58F-E1A7494543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DF6FC-2809-C142-9C61-C15DD5480C82}" type="datetimeFigureOut">
              <a:rPr kumimoji="1" lang="ja-JP" altLang="en-US" smtClean="0"/>
              <a:t>2024/1/3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32BE6EF5-4228-8824-B297-999F8A55FE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27CA54D-2336-887A-79B8-02AD312AF3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6DC0F-3640-0248-8851-820917A4F8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64411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7BAB7DF-7D11-073E-DADF-59E9970D34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5565899-6AA8-0CBD-550B-C0A16303BB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43D6C9A-9761-6334-9B0B-C81C994467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42E887F-D519-442C-47E9-C51139369A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DF6FC-2809-C142-9C61-C15DD5480C82}" type="datetimeFigureOut">
              <a:rPr kumimoji="1" lang="ja-JP" altLang="en-US" smtClean="0"/>
              <a:t>2024/1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566D0E5-1DC3-97D6-9D23-251B7DAEA3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672BE19-C096-1B02-60A4-ADA6F286E8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6DC0F-3640-0248-8851-820917A4F8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44821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17A3287-CA2C-69C0-0B7F-138C5BDE5B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3A6A77B9-000E-C10D-4BEC-767A3B1E97D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A260078-C2F4-67DA-737D-8B5DC41817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6A03784-8D29-73D2-C4D2-B631B00794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DF6FC-2809-C142-9C61-C15DD5480C82}" type="datetimeFigureOut">
              <a:rPr kumimoji="1" lang="ja-JP" altLang="en-US" smtClean="0"/>
              <a:t>2024/1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17DA470-08A3-212B-7EA2-95FA6BD227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839D51E-DB1E-4E48-4438-06045398D1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6DC0F-3640-0248-8851-820917A4F8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87882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0D02E96-1295-244D-A0DD-D0A75407E7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619604F-8F98-2CE0-FF11-0480786FD8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EDC75BD-8D37-CCC6-69A1-7B0E23C4069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FDF6FC-2809-C142-9C61-C15DD5480C82}" type="datetimeFigureOut">
              <a:rPr kumimoji="1" lang="ja-JP" altLang="en-US" smtClean="0"/>
              <a:t>2024/1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B328790-3A3E-3B3C-52F0-2E4E05A8963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EF40E8A-CD84-1121-4FD3-68A7A290A87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D6DC0F-3640-0248-8851-820917A4F8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70426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91B9B51-F7A3-3C63-4F87-3FD280A7D8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98098" y="820736"/>
            <a:ext cx="10515600" cy="1325563"/>
          </a:xfrm>
        </p:spPr>
        <p:txBody>
          <a:bodyPr>
            <a:normAutofit/>
          </a:bodyPr>
          <a:lstStyle/>
          <a:p>
            <a:br>
              <a:rPr kumimoji="1" lang="en-US" altLang="ja-JP" sz="2800" dirty="0">
                <a:latin typeface="Helvetica" pitchFamily="2" charset="0"/>
              </a:rPr>
            </a:br>
            <a:r>
              <a:rPr kumimoji="1" lang="en-US" altLang="ja-JP" sz="2800" dirty="0">
                <a:latin typeface="Helvetica" pitchFamily="2" charset="0"/>
              </a:rPr>
              <a:t>Primers and probes used for </a:t>
            </a:r>
            <a:r>
              <a:rPr kumimoji="1" lang="en-US" altLang="ja-JP" sz="2800" dirty="0" err="1">
                <a:latin typeface="Helvetica" pitchFamily="2" charset="0"/>
              </a:rPr>
              <a:t>ddPCR</a:t>
            </a:r>
            <a:r>
              <a:rPr kumimoji="1" lang="en-US" altLang="ja-JP" sz="2800" dirty="0">
                <a:latin typeface="Helvetica" pitchFamily="2" charset="0"/>
              </a:rPr>
              <a:t> and PCR</a:t>
            </a:r>
            <a:endParaRPr kumimoji="1" lang="ja-JP" altLang="en-US" sz="2800">
              <a:latin typeface="Helvetica" pitchFamily="2" charset="0"/>
            </a:endParaRPr>
          </a:p>
        </p:txBody>
      </p:sp>
      <p:graphicFrame>
        <p:nvGraphicFramePr>
          <p:cNvPr id="9" name="表 9">
            <a:extLst>
              <a:ext uri="{FF2B5EF4-FFF2-40B4-BE49-F238E27FC236}">
                <a16:creationId xmlns:a16="http://schemas.microsoft.com/office/drawing/2014/main" id="{09A0F79B-F124-B25F-2012-E5A8F9E8F93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46168833"/>
              </p:ext>
            </p:extLst>
          </p:nvPr>
        </p:nvGraphicFramePr>
        <p:xfrm>
          <a:off x="998098" y="2146299"/>
          <a:ext cx="10141680" cy="333883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535420">
                  <a:extLst>
                    <a:ext uri="{9D8B030D-6E8A-4147-A177-3AD203B41FA5}">
                      <a16:colId xmlns:a16="http://schemas.microsoft.com/office/drawing/2014/main" val="3268456054"/>
                    </a:ext>
                  </a:extLst>
                </a:gridCol>
                <a:gridCol w="2535420">
                  <a:extLst>
                    <a:ext uri="{9D8B030D-6E8A-4147-A177-3AD203B41FA5}">
                      <a16:colId xmlns:a16="http://schemas.microsoft.com/office/drawing/2014/main" val="4288807849"/>
                    </a:ext>
                  </a:extLst>
                </a:gridCol>
                <a:gridCol w="2633273">
                  <a:extLst>
                    <a:ext uri="{9D8B030D-6E8A-4147-A177-3AD203B41FA5}">
                      <a16:colId xmlns:a16="http://schemas.microsoft.com/office/drawing/2014/main" val="4018213464"/>
                    </a:ext>
                  </a:extLst>
                </a:gridCol>
                <a:gridCol w="2437567">
                  <a:extLst>
                    <a:ext uri="{9D8B030D-6E8A-4147-A177-3AD203B41FA5}">
                      <a16:colId xmlns:a16="http://schemas.microsoft.com/office/drawing/2014/main" val="3027310098"/>
                    </a:ext>
                  </a:extLst>
                </a:gridCol>
              </a:tblGrid>
              <a:tr h="435701">
                <a:tc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ja-JP" sz="1800" kern="100" dirty="0" err="1">
                          <a:effectLst/>
                          <a:latin typeface="Century" panose="020406040505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Fw</a:t>
                      </a:r>
                      <a:r>
                        <a:rPr lang="en-US" altLang="ja-JP" sz="1800" kern="100" dirty="0">
                          <a:effectLst/>
                          <a:latin typeface="Century" panose="020406040505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 Primer</a:t>
                      </a:r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ja-JP" sz="1800" kern="100" dirty="0" err="1">
                          <a:effectLst/>
                          <a:latin typeface="Century" panose="020406040505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Rv</a:t>
                      </a:r>
                      <a:r>
                        <a:rPr lang="en-US" altLang="ja-JP" sz="1800" kern="100" dirty="0">
                          <a:effectLst/>
                          <a:latin typeface="Century" panose="020406040505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 Primer</a:t>
                      </a:r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ja-JP" sz="1800" kern="100" dirty="0">
                          <a:effectLst/>
                          <a:latin typeface="Century" panose="020406040505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Probe</a:t>
                      </a:r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0185188"/>
                  </a:ext>
                </a:extLst>
              </a:tr>
              <a:tr h="1074333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i="1" dirty="0">
                          <a:latin typeface="Helvetica" pitchFamily="2" charset="0"/>
                        </a:rPr>
                        <a:t>omcin5</a:t>
                      </a:r>
                      <a:endParaRPr kumimoji="1" lang="ja-JP" altLang="en-US" i="1">
                        <a:latin typeface="Helvetica" pitchFamily="2" charset="0"/>
                      </a:endParaRPr>
                    </a:p>
                    <a:p>
                      <a:endParaRPr kumimoji="1" lang="ja-JP" altLang="en-US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kern="100" dirty="0">
                          <a:effectLst/>
                          <a:latin typeface="Helvetica" pitchFamily="2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AGAGCACAACAACAG</a:t>
                      </a:r>
                      <a:endParaRPr lang="ja-JP" altLang="ja-JP" sz="1800" kern="100">
                        <a:effectLst/>
                        <a:latin typeface="Helvetica" pitchFamily="2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endParaRPr kumimoji="1" lang="ja-JP" altLang="en-US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kern="100" dirty="0">
                          <a:effectLst/>
                          <a:latin typeface="Helvetica" pitchFamily="2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CCAAGATGAAGTAATTGTA</a:t>
                      </a:r>
                      <a:endParaRPr lang="ja-JP" altLang="ja-JP" sz="1800" kern="100">
                        <a:effectLst/>
                        <a:latin typeface="Helvetica" pitchFamily="2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endParaRPr kumimoji="1" lang="ja-JP" altLang="en-US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800" kern="100" dirty="0">
                          <a:effectLst/>
                          <a:latin typeface="Helvetica" pitchFamily="2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CACAATCCATTACTCCATCA</a:t>
                      </a:r>
                      <a:endParaRPr lang="ja-JP" altLang="ja-JP" sz="1800" kern="100">
                        <a:effectLst/>
                        <a:latin typeface="Helvetica" pitchFamily="2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endParaRPr kumimoji="1" lang="ja-JP" altLang="en-US">
                        <a:latin typeface="Helvetica" pitchFamily="2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41138870"/>
                  </a:ext>
                </a:extLst>
              </a:tr>
              <a:tr h="75203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1" u="none" strike="noStrike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actb1</a:t>
                      </a:r>
                      <a:endParaRPr kumimoji="1" lang="ja-JP" altLang="en-US" i="1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CCTCCATTGTTGGACGA </a:t>
                      </a:r>
                      <a:endParaRPr lang="en-US" altLang="ja-JP" dirty="0">
                        <a:effectLst/>
                        <a:latin typeface="Helvetica" pitchFamily="2" charset="0"/>
                      </a:endParaRPr>
                    </a:p>
                    <a:p>
                      <a:endParaRPr kumimoji="1" lang="ja-JP" altLang="en-US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ATAGGAGTCTTTCTGTCCC </a:t>
                      </a:r>
                      <a:endParaRPr lang="en-US" altLang="ja-JP" dirty="0">
                        <a:effectLst/>
                        <a:latin typeface="Helvetica" pitchFamily="2" charset="0"/>
                      </a:endParaRPr>
                    </a:p>
                    <a:p>
                      <a:endParaRPr kumimoji="1" lang="ja-JP" altLang="en-US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CCATCACTCCCTGATGTC </a:t>
                      </a:r>
                      <a:endParaRPr lang="en-US" altLang="ja-JP" dirty="0">
                        <a:effectLst/>
                        <a:latin typeface="Helvetica" pitchFamily="2" charset="0"/>
                      </a:endParaRPr>
                    </a:p>
                    <a:p>
                      <a:endParaRPr kumimoji="1" lang="ja-JP" altLang="en-US">
                        <a:latin typeface="Helvetica" pitchFamily="2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77323893"/>
                  </a:ext>
                </a:extLst>
              </a:tr>
              <a:tr h="75203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i="1" dirty="0">
                          <a:latin typeface="Helvetica" pitchFamily="2" charset="0"/>
                        </a:rPr>
                        <a:t>cdh17</a:t>
                      </a:r>
                      <a:endParaRPr kumimoji="1" lang="ja-JP" altLang="en-US" i="1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GATTTAGGTGACACTATAGGTAGGTAATTCGATTGGTCATCTGC</a:t>
                      </a:r>
                      <a:r>
                        <a:rPr lang="ja-JP" altLang="ja-JP">
                          <a:effectLst/>
                          <a:latin typeface="Helvetica" pitchFamily="2" charset="0"/>
                        </a:rPr>
                        <a:t> </a:t>
                      </a:r>
                      <a:endParaRPr kumimoji="1" lang="ja-JP" altLang="en-US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TAATACGACTCACTATAGGGTGTCTTCTGGAGTTTAGGGTAGTTG</a:t>
                      </a:r>
                      <a:r>
                        <a:rPr lang="ja-JP" altLang="ja-JP">
                          <a:effectLst/>
                          <a:latin typeface="Helvetica" pitchFamily="2" charset="0"/>
                        </a:rPr>
                        <a:t> </a:t>
                      </a:r>
                      <a:endParaRPr kumimoji="1" lang="ja-JP" altLang="en-US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>
                        <a:latin typeface="Helvetica" pitchFamily="2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6786807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27F182E-1420-831A-03F1-CE7C198F2B5F}"/>
              </a:ext>
            </a:extLst>
          </p:cNvPr>
          <p:cNvSpPr txBox="1"/>
          <p:nvPr/>
        </p:nvSpPr>
        <p:spPr>
          <a:xfrm>
            <a:off x="998098" y="5593710"/>
            <a:ext cx="47307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>
                <a:latin typeface="Helvetica" pitchFamily="2" charset="0"/>
              </a:rPr>
              <a:t>myd88</a:t>
            </a:r>
            <a:r>
              <a:rPr kumimoji="1" lang="en-US" altLang="ja-JP" dirty="0">
                <a:latin typeface="Helvetica" pitchFamily="2" charset="0"/>
              </a:rPr>
              <a:t>: </a:t>
            </a:r>
            <a:r>
              <a:rPr lang="en-US" altLang="ja-JP" b="0" i="0" u="none" strike="noStrike" dirty="0" err="1">
                <a:effectLst/>
                <a:latin typeface="Helvetica" pitchFamily="2" charset="0"/>
              </a:rPr>
              <a:t>UniqueAssayID</a:t>
            </a:r>
            <a:r>
              <a:rPr lang="en-US" altLang="ja-JP" b="0" i="0" u="none" strike="noStrike" dirty="0">
                <a:effectLst/>
                <a:latin typeface="Helvetica" pitchFamily="2" charset="0"/>
              </a:rPr>
              <a:t> = qDreCEP0034467</a:t>
            </a:r>
            <a:endParaRPr kumimoji="1" lang="ja-JP" altLang="en-US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67805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30</Words>
  <Application>Microsoft Macintosh PowerPoint</Application>
  <PresentationFormat>ワイド画面</PresentationFormat>
  <Paragraphs>1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entury</vt:lpstr>
      <vt:lpstr>Helvetica</vt:lpstr>
      <vt:lpstr>Office テーマ</vt:lpstr>
      <vt:lpstr> Primers and probes used for ddPCR and PCR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able2 Primers and probes used for ddPCR and PCR</dc:title>
  <dc:creator>Microsoft Office User</dc:creator>
  <cp:lastModifiedBy>Microsoft Office User</cp:lastModifiedBy>
  <cp:revision>4</cp:revision>
  <dcterms:created xsi:type="dcterms:W3CDTF">2023-12-21T05:49:21Z</dcterms:created>
  <dcterms:modified xsi:type="dcterms:W3CDTF">2024-01-31T06:52:58Z</dcterms:modified>
</cp:coreProperties>
</file>